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5" r:id="rId2"/>
    <p:sldId id="266" r:id="rId3"/>
    <p:sldId id="267" r:id="rId4"/>
    <p:sldId id="268" r:id="rId5"/>
    <p:sldId id="270" r:id="rId6"/>
    <p:sldId id="281" r:id="rId7"/>
  </p:sldIdLst>
  <p:sldSz cx="9144000" cy="6858000" type="screen4x3"/>
  <p:notesSz cx="6858000" cy="9144000"/>
  <p:defaultTextStyle>
    <a:defPPr>
      <a:defRPr lang="en-US"/>
    </a:defPPr>
    <a:lvl1pPr marL="0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92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86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79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373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466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558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652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744" algn="l" defTabSz="45709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D102"/>
    <a:srgbClr val="FF0202"/>
    <a:srgbClr val="DE39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34563" autoAdjust="0"/>
    <p:restoredTop sz="86398" autoAdjust="0"/>
  </p:normalViewPr>
  <p:slideViewPr>
    <p:cSldViewPr snapToGrid="0" snapToObjects="1">
      <p:cViewPr>
        <p:scale>
          <a:sx n="131" d="100"/>
          <a:sy n="131" d="100"/>
        </p:scale>
        <p:origin x="-1866" y="30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222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JMC%20MacBook%20Pro:Users:jmc:JMC%20Documents:NCI%20Stuff:DRP%20Manuscripts:Cohn%20et%20al%20Rebuttal:Alu%20Integrations%20(version%20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35804899387599"/>
          <c:y val="2.5697047158043999E-2"/>
          <c:w val="0.85471412948381398"/>
          <c:h val="0.80988189728178706"/>
        </c:manualLayout>
      </c:layout>
      <c:lineChart>
        <c:grouping val="standard"/>
        <c:varyColors val="0"/>
        <c:ser>
          <c:idx val="0"/>
          <c:order val="0"/>
          <c:marker>
            <c:symbol val="none"/>
          </c:marker>
          <c:cat>
            <c:strRef>
              <c:f>Sheet1!$M$222:$DG$222</c:f>
              <c:strCache>
                <c:ptCount val="97"/>
                <c:pt idx="0">
                  <c:v>C</c:v>
                </c:pt>
                <c:pt idx="1">
                  <c:v>C</c:v>
                </c:pt>
                <c:pt idx="2">
                  <c:v>C</c:v>
                </c:pt>
                <c:pt idx="3">
                  <c:v>T</c:v>
                </c:pt>
                <c:pt idx="4">
                  <c:v>T</c:v>
                </c:pt>
                <c:pt idx="5">
                  <c:v>T</c:v>
                </c:pt>
                <c:pt idx="6">
                  <c:v>T</c:v>
                </c:pt>
                <c:pt idx="7">
                  <c:v>A</c:v>
                </c:pt>
                <c:pt idx="8">
                  <c:v>G</c:v>
                </c:pt>
                <c:pt idx="9">
                  <c:v>T</c:v>
                </c:pt>
                <c:pt idx="10">
                  <c:v>C</c:v>
                </c:pt>
                <c:pt idx="11">
                  <c:v>A</c:v>
                </c:pt>
                <c:pt idx="12">
                  <c:v>G</c:v>
                </c:pt>
                <c:pt idx="13">
                  <c:v>T</c:v>
                </c:pt>
                <c:pt idx="14">
                  <c:v>G</c:v>
                </c:pt>
                <c:pt idx="15">
                  <c:v>T</c:v>
                </c:pt>
                <c:pt idx="16">
                  <c:v>G</c:v>
                </c:pt>
                <c:pt idx="17">
                  <c:v>G</c:v>
                </c:pt>
                <c:pt idx="18">
                  <c:v>A</c:v>
                </c:pt>
                <c:pt idx="19">
                  <c:v>A</c:v>
                </c:pt>
                <c:pt idx="20">
                  <c:v>A</c:v>
                </c:pt>
                <c:pt idx="21">
                  <c:v>A</c:v>
                </c:pt>
                <c:pt idx="22">
                  <c:v>T</c:v>
                </c:pt>
                <c:pt idx="23">
                  <c:v>C</c:v>
                </c:pt>
                <c:pt idx="24">
                  <c:v>T</c:v>
                </c:pt>
                <c:pt idx="25">
                  <c:v>C</c:v>
                </c:pt>
                <c:pt idx="26">
                  <c:v>T</c:v>
                </c:pt>
                <c:pt idx="27">
                  <c:v>A</c:v>
                </c:pt>
                <c:pt idx="28">
                  <c:v>G</c:v>
                </c:pt>
                <c:pt idx="29">
                  <c:v>C</c:v>
                </c:pt>
                <c:pt idx="30">
                  <c:v>A</c:v>
                </c:pt>
                <c:pt idx="31">
                  <c:v>G</c:v>
                </c:pt>
                <c:pt idx="32">
                  <c:v>G</c:v>
                </c:pt>
                <c:pt idx="33">
                  <c:v>G</c:v>
                </c:pt>
                <c:pt idx="34">
                  <c:v>A</c:v>
                </c:pt>
                <c:pt idx="35">
                  <c:v>T</c:v>
                </c:pt>
                <c:pt idx="36">
                  <c:v>T</c:v>
                </c:pt>
                <c:pt idx="37">
                  <c:v>A</c:v>
                </c:pt>
                <c:pt idx="38">
                  <c:v>C</c:v>
                </c:pt>
                <c:pt idx="39">
                  <c:v>A</c:v>
                </c:pt>
                <c:pt idx="40">
                  <c:v>G</c:v>
                </c:pt>
                <c:pt idx="41">
                  <c:v>G</c:v>
                </c:pt>
                <c:pt idx="42">
                  <c:v>T</c:v>
                </c:pt>
                <c:pt idx="43">
                  <c:v>G</c:v>
                </c:pt>
                <c:pt idx="44">
                  <c:v>T</c:v>
                </c:pt>
                <c:pt idx="45">
                  <c:v>G</c:v>
                </c:pt>
                <c:pt idx="46">
                  <c:v>A</c:v>
                </c:pt>
                <c:pt idx="47">
                  <c:v>G</c:v>
                </c:pt>
                <c:pt idx="48">
                  <c:v>C</c:v>
                </c:pt>
                <c:pt idx="49">
                  <c:v>C</c:v>
                </c:pt>
                <c:pt idx="50">
                  <c:v>A</c:v>
                </c:pt>
                <c:pt idx="51">
                  <c:v>C</c:v>
                </c:pt>
                <c:pt idx="52">
                  <c:v>C</c:v>
                </c:pt>
                <c:pt idx="53">
                  <c:v>A</c:v>
                </c:pt>
                <c:pt idx="54">
                  <c:v>C</c:v>
                </c:pt>
                <c:pt idx="55">
                  <c:v>G</c:v>
                </c:pt>
                <c:pt idx="56">
                  <c:v>C</c:v>
                </c:pt>
                <c:pt idx="57">
                  <c:v>C</c:v>
                </c:pt>
                <c:pt idx="58">
                  <c:v>T</c:v>
                </c:pt>
                <c:pt idx="59">
                  <c:v>G</c:v>
                </c:pt>
                <c:pt idx="60">
                  <c:v>G</c:v>
                </c:pt>
                <c:pt idx="61">
                  <c:v>C</c:v>
                </c:pt>
                <c:pt idx="62">
                  <c:v>C</c:v>
                </c:pt>
                <c:pt idx="63">
                  <c:v>T</c:v>
                </c:pt>
                <c:pt idx="64">
                  <c:v>A</c:v>
                </c:pt>
                <c:pt idx="65">
                  <c:v>T</c:v>
                </c:pt>
                <c:pt idx="66">
                  <c:v>T</c:v>
                </c:pt>
                <c:pt idx="67">
                  <c:v>T</c:v>
                </c:pt>
                <c:pt idx="68">
                  <c:v>G</c:v>
                </c:pt>
                <c:pt idx="69">
                  <c:v>G</c:v>
                </c:pt>
                <c:pt idx="70">
                  <c:v>A</c:v>
                </c:pt>
                <c:pt idx="71">
                  <c:v>G</c:v>
                </c:pt>
                <c:pt idx="72">
                  <c:v>A</c:v>
                </c:pt>
                <c:pt idx="73">
                  <c:v>T</c:v>
                </c:pt>
                <c:pt idx="74">
                  <c:v>T</c:v>
                </c:pt>
                <c:pt idx="75">
                  <c:v>T</c:v>
                </c:pt>
                <c:pt idx="76">
                  <c:v>T</c:v>
                </c:pt>
                <c:pt idx="77">
                  <c:v>T</c:v>
                </c:pt>
                <c:pt idx="78">
                  <c:v>T</c:v>
                </c:pt>
                <c:pt idx="79">
                  <c:v>A</c:v>
                </c:pt>
                <c:pt idx="80">
                  <c:v>T</c:v>
                </c:pt>
                <c:pt idx="81">
                  <c:v>G</c:v>
                </c:pt>
                <c:pt idx="82">
                  <c:v>A</c:v>
                </c:pt>
                <c:pt idx="83">
                  <c:v>A</c:v>
                </c:pt>
                <c:pt idx="84">
                  <c:v>A</c:v>
                </c:pt>
                <c:pt idx="85">
                  <c:v>A</c:v>
                </c:pt>
                <c:pt idx="86">
                  <c:v>C</c:v>
                </c:pt>
                <c:pt idx="87">
                  <c:v>C</c:v>
                </c:pt>
                <c:pt idx="88">
                  <c:v>A</c:v>
                </c:pt>
                <c:pt idx="89">
                  <c:v>G</c:v>
                </c:pt>
                <c:pt idx="90">
                  <c:v>C</c:v>
                </c:pt>
                <c:pt idx="91">
                  <c:v>A</c:v>
                </c:pt>
                <c:pt idx="92">
                  <c:v>T</c:v>
                </c:pt>
                <c:pt idx="93">
                  <c:v>C</c:v>
                </c:pt>
                <c:pt idx="94">
                  <c:v>A</c:v>
                </c:pt>
                <c:pt idx="95">
                  <c:v>C</c:v>
                </c:pt>
                <c:pt idx="96">
                  <c:v>A</c:v>
                </c:pt>
              </c:strCache>
            </c:strRef>
          </c:cat>
          <c:val>
            <c:numRef>
              <c:f>Sheet1!$M$221:$DG$221</c:f>
              <c:numCache>
                <c:formatCode>General</c:formatCode>
                <c:ptCount val="9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0.65573770491803296</c:v>
                </c:pt>
                <c:pt idx="55">
                  <c:v>0.50819672131147497</c:v>
                </c:pt>
                <c:pt idx="56">
                  <c:v>0.69398907103825103</c:v>
                </c:pt>
                <c:pt idx="57">
                  <c:v>0.67759562841529997</c:v>
                </c:pt>
                <c:pt idx="58">
                  <c:v>0.48633879781420802</c:v>
                </c:pt>
                <c:pt idx="59">
                  <c:v>0.72131147540983598</c:v>
                </c:pt>
                <c:pt idx="60">
                  <c:v>0.71038251366120198</c:v>
                </c:pt>
                <c:pt idx="61">
                  <c:v>0.71038251366120198</c:v>
                </c:pt>
                <c:pt idx="62">
                  <c:v>0.51912568306010898</c:v>
                </c:pt>
                <c:pt idx="63">
                  <c:v>0.39344262295082</c:v>
                </c:pt>
                <c:pt idx="64">
                  <c:v>0.48087431693989102</c:v>
                </c:pt>
                <c:pt idx="65">
                  <c:v>0.33879781420764998</c:v>
                </c:pt>
                <c:pt idx="66">
                  <c:v>0.34972677595628399</c:v>
                </c:pt>
                <c:pt idx="67">
                  <c:v>0.29508196721311503</c:v>
                </c:pt>
                <c:pt idx="68">
                  <c:v>0.33333333333333298</c:v>
                </c:pt>
                <c:pt idx="69">
                  <c:v>0.29508196721311503</c:v>
                </c:pt>
                <c:pt idx="70">
                  <c:v>0.37704918032786899</c:v>
                </c:pt>
                <c:pt idx="71">
                  <c:v>0.30054644808743203</c:v>
                </c:pt>
                <c:pt idx="72">
                  <c:v>0.33333333333333298</c:v>
                </c:pt>
                <c:pt idx="73">
                  <c:v>0.35519125683060099</c:v>
                </c:pt>
                <c:pt idx="74">
                  <c:v>0.43169398907103801</c:v>
                </c:pt>
                <c:pt idx="75">
                  <c:v>0.404371584699454</c:v>
                </c:pt>
                <c:pt idx="76">
                  <c:v>0.415300546448087</c:v>
                </c:pt>
                <c:pt idx="77">
                  <c:v>0.28961748633879802</c:v>
                </c:pt>
                <c:pt idx="78">
                  <c:v>0.30601092896174897</c:v>
                </c:pt>
                <c:pt idx="79">
                  <c:v>0.31693989071038198</c:v>
                </c:pt>
                <c:pt idx="80">
                  <c:v>0.32786885245901598</c:v>
                </c:pt>
                <c:pt idx="81">
                  <c:v>0.32786885245901598</c:v>
                </c:pt>
                <c:pt idx="82">
                  <c:v>0.27322404371584702</c:v>
                </c:pt>
                <c:pt idx="83">
                  <c:v>0.33879781420764998</c:v>
                </c:pt>
                <c:pt idx="84">
                  <c:v>0.31693989071038198</c:v>
                </c:pt>
                <c:pt idx="85">
                  <c:v>0.31693989071038198</c:v>
                </c:pt>
                <c:pt idx="86">
                  <c:v>0.31693989071038198</c:v>
                </c:pt>
                <c:pt idx="87">
                  <c:v>0.29508196721311503</c:v>
                </c:pt>
                <c:pt idx="88">
                  <c:v>0.32786885245901598</c:v>
                </c:pt>
                <c:pt idx="89">
                  <c:v>0.32240437158469898</c:v>
                </c:pt>
                <c:pt idx="90">
                  <c:v>0.30054644808743203</c:v>
                </c:pt>
                <c:pt idx="91">
                  <c:v>0.29508196721311503</c:v>
                </c:pt>
                <c:pt idx="92">
                  <c:v>0.27868852459016402</c:v>
                </c:pt>
                <c:pt idx="93">
                  <c:v>0.34972677595628399</c:v>
                </c:pt>
                <c:pt idx="94">
                  <c:v>0.34426229508196698</c:v>
                </c:pt>
                <c:pt idx="95">
                  <c:v>0.32240437158469898</c:v>
                </c:pt>
                <c:pt idx="96">
                  <c:v>0.3442622950819669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F1B-F945-B06C-6B2403FC7B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7514112"/>
        <c:axId val="127516032"/>
      </c:lineChart>
      <c:catAx>
        <c:axId val="1275141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800"/>
                </a:pPr>
                <a:r>
                  <a:rPr lang="en-US" sz="1800"/>
                  <a:t>Consensus Sequence</a:t>
                </a:r>
              </a:p>
            </c:rich>
          </c:tx>
          <c:layout>
            <c:manualLayout>
              <c:xMode val="edge"/>
              <c:yMode val="edge"/>
              <c:x val="0.45289971566054199"/>
              <c:y val="0.89488933956143901"/>
            </c:manualLayout>
          </c:layout>
          <c:overlay val="0"/>
          <c:spPr>
            <a:ln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27516032"/>
        <c:crosses val="autoZero"/>
        <c:auto val="1"/>
        <c:lblAlgn val="ctr"/>
        <c:lblOffset val="0"/>
        <c:noMultiLvlLbl val="0"/>
      </c:catAx>
      <c:valAx>
        <c:axId val="127516032"/>
        <c:scaling>
          <c:orientation val="minMax"/>
          <c:max val="1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/>
                  <a:t>Frequency</a:t>
                </a:r>
                <a:r>
                  <a:rPr lang="en-US" sz="1600" baseline="0"/>
                  <a:t> of Consensus Base</a:t>
                </a:r>
              </a:p>
              <a:p>
                <a:pPr>
                  <a:defRPr sz="1600"/>
                </a:pPr>
                <a:endParaRPr lang="en-US" sz="16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275141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360BC5-D903-CA4C-8DA2-6ED44E731E72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96DBC-0BF5-E74E-B37D-CCF765B84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125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096DBC-0BF5-E74E-B37D-CCF765B84C5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335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2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6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49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965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92975" y="311150"/>
            <a:ext cx="2262188" cy="66325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240" y="311150"/>
            <a:ext cx="6637337" cy="66325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977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627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9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2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65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74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60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812925"/>
            <a:ext cx="4449762" cy="5130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5402" y="1812925"/>
            <a:ext cx="4449763" cy="5130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063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2" indent="0">
              <a:buNone/>
              <a:defRPr sz="2000" b="1"/>
            </a:lvl2pPr>
            <a:lvl3pPr marL="914186" indent="0">
              <a:buNone/>
              <a:defRPr sz="1800" b="1"/>
            </a:lvl3pPr>
            <a:lvl4pPr marL="1371279" indent="0">
              <a:buNone/>
              <a:defRPr sz="1600" b="1"/>
            </a:lvl4pPr>
            <a:lvl5pPr marL="1828373" indent="0">
              <a:buNone/>
              <a:defRPr sz="1600" b="1"/>
            </a:lvl5pPr>
            <a:lvl6pPr marL="2285466" indent="0">
              <a:buNone/>
              <a:defRPr sz="1600" b="1"/>
            </a:lvl6pPr>
            <a:lvl7pPr marL="2742558" indent="0">
              <a:buNone/>
              <a:defRPr sz="1600" b="1"/>
            </a:lvl7pPr>
            <a:lvl8pPr marL="3199652" indent="0">
              <a:buNone/>
              <a:defRPr sz="1600" b="1"/>
            </a:lvl8pPr>
            <a:lvl9pPr marL="365674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2" indent="0">
              <a:buNone/>
              <a:defRPr sz="2000" b="1"/>
            </a:lvl2pPr>
            <a:lvl3pPr marL="914186" indent="0">
              <a:buNone/>
              <a:defRPr sz="1800" b="1"/>
            </a:lvl3pPr>
            <a:lvl4pPr marL="1371279" indent="0">
              <a:buNone/>
              <a:defRPr sz="1600" b="1"/>
            </a:lvl4pPr>
            <a:lvl5pPr marL="1828373" indent="0">
              <a:buNone/>
              <a:defRPr sz="1600" b="1"/>
            </a:lvl5pPr>
            <a:lvl6pPr marL="2285466" indent="0">
              <a:buNone/>
              <a:defRPr sz="1600" b="1"/>
            </a:lvl6pPr>
            <a:lvl7pPr marL="2742558" indent="0">
              <a:buNone/>
              <a:defRPr sz="1600" b="1"/>
            </a:lvl7pPr>
            <a:lvl8pPr marL="3199652" indent="0">
              <a:buNone/>
              <a:defRPr sz="1600" b="1"/>
            </a:lvl8pPr>
            <a:lvl9pPr marL="365674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08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5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380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092" indent="0">
              <a:buNone/>
              <a:defRPr sz="1200"/>
            </a:lvl2pPr>
            <a:lvl3pPr marL="914186" indent="0">
              <a:buNone/>
              <a:defRPr sz="1000"/>
            </a:lvl3pPr>
            <a:lvl4pPr marL="1371279" indent="0">
              <a:buNone/>
              <a:defRPr sz="900"/>
            </a:lvl4pPr>
            <a:lvl5pPr marL="1828373" indent="0">
              <a:buNone/>
              <a:defRPr sz="900"/>
            </a:lvl5pPr>
            <a:lvl6pPr marL="2285466" indent="0">
              <a:buNone/>
              <a:defRPr sz="900"/>
            </a:lvl6pPr>
            <a:lvl7pPr marL="2742558" indent="0">
              <a:buNone/>
              <a:defRPr sz="900"/>
            </a:lvl7pPr>
            <a:lvl8pPr marL="3199652" indent="0">
              <a:buNone/>
              <a:defRPr sz="900"/>
            </a:lvl8pPr>
            <a:lvl9pPr marL="365674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40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092" indent="0">
              <a:buNone/>
              <a:defRPr sz="2800"/>
            </a:lvl2pPr>
            <a:lvl3pPr marL="914186" indent="0">
              <a:buNone/>
              <a:defRPr sz="2400"/>
            </a:lvl3pPr>
            <a:lvl4pPr marL="1371279" indent="0">
              <a:buNone/>
              <a:defRPr sz="2000"/>
            </a:lvl4pPr>
            <a:lvl5pPr marL="1828373" indent="0">
              <a:buNone/>
              <a:defRPr sz="2000"/>
            </a:lvl5pPr>
            <a:lvl6pPr marL="2285466" indent="0">
              <a:buNone/>
              <a:defRPr sz="2000"/>
            </a:lvl6pPr>
            <a:lvl7pPr marL="2742558" indent="0">
              <a:buNone/>
              <a:defRPr sz="2000"/>
            </a:lvl7pPr>
            <a:lvl8pPr marL="3199652" indent="0">
              <a:buNone/>
              <a:defRPr sz="2000"/>
            </a:lvl8pPr>
            <a:lvl9pPr marL="365674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092" indent="0">
              <a:buNone/>
              <a:defRPr sz="1200"/>
            </a:lvl2pPr>
            <a:lvl3pPr marL="914186" indent="0">
              <a:buNone/>
              <a:defRPr sz="1000"/>
            </a:lvl3pPr>
            <a:lvl4pPr marL="1371279" indent="0">
              <a:buNone/>
              <a:defRPr sz="900"/>
            </a:lvl4pPr>
            <a:lvl5pPr marL="1828373" indent="0">
              <a:buNone/>
              <a:defRPr sz="900"/>
            </a:lvl5pPr>
            <a:lvl6pPr marL="2285466" indent="0">
              <a:buNone/>
              <a:defRPr sz="900"/>
            </a:lvl6pPr>
            <a:lvl7pPr marL="2742558" indent="0">
              <a:buNone/>
              <a:defRPr sz="900"/>
            </a:lvl7pPr>
            <a:lvl8pPr marL="3199652" indent="0">
              <a:buNone/>
              <a:defRPr sz="900"/>
            </a:lvl8pPr>
            <a:lvl9pPr marL="365674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924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18" tIns="45709" rIns="91418" bIns="4570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18" tIns="45709" rIns="91418" bIns="4570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90002-74E8-C44F-B23E-0B9E9B7B39DC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8520A-EB24-D940-A433-B58045894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412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09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20" indent="-342820" algn="l" defTabSz="457092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76" indent="-285684" algn="l" defTabSz="457092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33" indent="-228546" algn="l" defTabSz="457092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25" indent="-228546" algn="l" defTabSz="457092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19" indent="-228546" algn="l" defTabSz="457092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12" indent="-228546" algn="l" defTabSz="45709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06" indent="-228546" algn="l" defTabSz="45709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198" indent="-228546" algn="l" defTabSz="45709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292" indent="-228546" algn="l" defTabSz="457092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92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86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279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73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66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58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652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744" algn="l" defTabSz="4570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emf"/><Relationship Id="rId4" Type="http://schemas.openxmlformats.org/officeDocument/2006/relationships/package" Target="../embeddings/Microsoft_Word_Document1.doc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emf"/><Relationship Id="rId5" Type="http://schemas.openxmlformats.org/officeDocument/2006/relationships/package" Target="../embeddings/Microsoft_Word_Document2.docx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804"/>
          <a:stretch/>
        </p:blipFill>
        <p:spPr bwMode="auto">
          <a:xfrm>
            <a:off x="3553308" y="1905000"/>
            <a:ext cx="5410200" cy="1134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8108" y="2895600"/>
            <a:ext cx="7602712" cy="5693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’bio; </a:t>
            </a:r>
            <a:r>
              <a:rPr lang="en-US" sz="3100" dirty="0"/>
              <a:t>CTTAAGCCTCAATAAAGCTTGCCTTGAG</a:t>
            </a:r>
            <a:r>
              <a:rPr lang="en-US" sz="2400" dirty="0"/>
              <a:t>O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540427" y="3429000"/>
            <a:ext cx="2381719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i="1" dirty="0"/>
              <a:t>LTR1  Prime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63363" y="1122810"/>
            <a:ext cx="373585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i="1" dirty="0"/>
              <a:t>Most Frequent Motif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133106" y="6488668"/>
            <a:ext cx="1044179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128273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1100325"/>
              </p:ext>
            </p:extLst>
          </p:nvPr>
        </p:nvGraphicFramePr>
        <p:xfrm>
          <a:off x="742950" y="583168"/>
          <a:ext cx="7658100" cy="590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Document" r:id="rId4" imgW="7658100" imgH="5905500" progId="Word.Document.12">
                  <p:embed/>
                </p:oleObj>
              </mc:Choice>
              <mc:Fallback>
                <p:oleObj name="Document" r:id="rId4" imgW="7658100" imgH="59055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2950" y="583168"/>
                        <a:ext cx="7658100" cy="5905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101006" y="191420"/>
            <a:ext cx="1820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“Integration Site”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072298" y="6488668"/>
            <a:ext cx="1044179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726362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3613043"/>
              </p:ext>
            </p:extLst>
          </p:nvPr>
        </p:nvGraphicFramePr>
        <p:xfrm>
          <a:off x="763588" y="240282"/>
          <a:ext cx="7027862" cy="7178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9" name="Document" r:id="rId5" imgW="8064500" imgH="8229600" progId="Word.Document.12">
                  <p:embed/>
                </p:oleObj>
              </mc:Choice>
              <mc:Fallback>
                <p:oleObj name="Document" r:id="rId5" imgW="8064500" imgH="82296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63588" y="240282"/>
                        <a:ext cx="7027862" cy="7178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072298" y="6488668"/>
            <a:ext cx="1042443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6100936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4515209"/>
              </p:ext>
            </p:extLst>
          </p:nvPr>
        </p:nvGraphicFramePr>
        <p:xfrm>
          <a:off x="2071917" y="397678"/>
          <a:ext cx="5752058" cy="6858072"/>
        </p:xfrm>
        <a:graphic>
          <a:graphicData uri="http://schemas.openxmlformats.org/drawingml/2006/table">
            <a:tbl>
              <a:tblPr/>
              <a:tblGrid>
                <a:gridCol w="575205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hn et al P3.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hn other patient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hn et al Patient 2.5   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darelli et al.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agner et al.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BMC PHA-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BMC PHA+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herrill-Mix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g19 random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ndom </a:t>
                      </a:r>
                      <a:r>
                        <a:rPr lang="en-US" sz="1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u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285753">
                <a:tc>
                  <a:txBody>
                    <a:bodyPr/>
                    <a:lstStyle/>
                    <a:p>
                      <a:pPr algn="l" fontAlgn="b"/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</a:tbl>
          </a:graphicData>
        </a:graphic>
      </p:graphicFrame>
      <p:grpSp>
        <p:nvGrpSpPr>
          <p:cNvPr id="16" name="Group 15"/>
          <p:cNvGrpSpPr/>
          <p:nvPr/>
        </p:nvGrpSpPr>
        <p:grpSpPr>
          <a:xfrm>
            <a:off x="3495353" y="854000"/>
            <a:ext cx="4357004" cy="5659154"/>
            <a:chOff x="79374" y="-2830161"/>
            <a:chExt cx="9098723" cy="12518322"/>
          </a:xfrm>
        </p:grpSpPr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374" y="-2830161"/>
              <a:ext cx="6340477" cy="929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9382" y="2520558"/>
              <a:ext cx="5968999" cy="8943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0347" y="3797014"/>
              <a:ext cx="6083300" cy="10281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13879" y="4927809"/>
              <a:ext cx="6238874" cy="10231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44626" y="-1366620"/>
              <a:ext cx="6943724" cy="8750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7721" y="6256874"/>
              <a:ext cx="6581775" cy="991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1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0822" y="7562356"/>
              <a:ext cx="6588123" cy="8659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2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34270" y="8797617"/>
              <a:ext cx="6962774" cy="8905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5910" y="-58670"/>
              <a:ext cx="6850377" cy="7969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14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5321" y="1247336"/>
              <a:ext cx="6962776" cy="8403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7" name="TextBox 16"/>
          <p:cNvSpPr txBox="1"/>
          <p:nvPr/>
        </p:nvSpPr>
        <p:spPr>
          <a:xfrm>
            <a:off x="8072298" y="6505380"/>
            <a:ext cx="1042443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4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5567432" y="654583"/>
            <a:ext cx="1" cy="266683"/>
          </a:xfrm>
          <a:prstGeom prst="straightConnector1">
            <a:avLst/>
          </a:prstGeom>
          <a:ln w="38100">
            <a:solidFill>
              <a:schemeClr val="accent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726767" y="285344"/>
            <a:ext cx="1825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“Integration Site”</a:t>
            </a:r>
          </a:p>
        </p:txBody>
      </p:sp>
    </p:spTree>
    <p:extLst>
      <p:ext uri="{BB962C8B-B14F-4D97-AF65-F5344CB8AC3E}">
        <p14:creationId xmlns:p14="http://schemas.microsoft.com/office/powerpoint/2010/main" val="2977059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CohnSingle+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624" r="5528" b="7278"/>
          <a:stretch/>
        </p:blipFill>
        <p:spPr>
          <a:xfrm>
            <a:off x="1262742" y="3949958"/>
            <a:ext cx="4615543" cy="895687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6219211" y="4197449"/>
            <a:ext cx="14045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hn, et al.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8973" y="4683966"/>
            <a:ext cx="101530" cy="182753"/>
          </a:xfrm>
          <a:prstGeom prst="rect">
            <a:avLst/>
          </a:prstGeom>
        </p:spPr>
      </p:pic>
      <p:pic>
        <p:nvPicPr>
          <p:cNvPr id="4" name="Picture 3" descr="PBMC+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15" b="6997"/>
          <a:stretch/>
        </p:blipFill>
        <p:spPr>
          <a:xfrm>
            <a:off x="1268963" y="2037641"/>
            <a:ext cx="4764833" cy="86728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219211" y="2262902"/>
            <a:ext cx="846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</a:p>
        </p:txBody>
      </p:sp>
      <p:pic>
        <p:nvPicPr>
          <p:cNvPr id="14" name="Picture 13" descr="PT3.3+strand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69"/>
          <a:stretch/>
        </p:blipFill>
        <p:spPr>
          <a:xfrm>
            <a:off x="1268963" y="4885965"/>
            <a:ext cx="4764833" cy="117893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219211" y="5317123"/>
            <a:ext cx="16122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T3.3 +Stran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072298" y="6501368"/>
            <a:ext cx="1044179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5</a:t>
            </a:r>
          </a:p>
        </p:txBody>
      </p:sp>
      <p:pic>
        <p:nvPicPr>
          <p:cNvPr id="5" name="Picture 4" descr="Science+.pn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0" t="34535" r="260" b="6023"/>
          <a:stretch/>
        </p:blipFill>
        <p:spPr>
          <a:xfrm>
            <a:off x="1256522" y="3030337"/>
            <a:ext cx="4778881" cy="78276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 flipH="1">
            <a:off x="6219211" y="3214624"/>
            <a:ext cx="18768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aldarelli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, et al.</a:t>
            </a:r>
          </a:p>
        </p:txBody>
      </p:sp>
      <p:pic>
        <p:nvPicPr>
          <p:cNvPr id="7" name="Picture 6" descr="HeLa_10k.pn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37" r="18285" b="20514"/>
          <a:stretch/>
        </p:blipFill>
        <p:spPr>
          <a:xfrm>
            <a:off x="1667656" y="1059194"/>
            <a:ext cx="4193498" cy="62719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219211" y="1261416"/>
            <a:ext cx="7364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 descr="PBMC+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432" b="6362"/>
          <a:stretch/>
        </p:blipFill>
        <p:spPr>
          <a:xfrm>
            <a:off x="1247931" y="1708879"/>
            <a:ext cx="4784570" cy="203338"/>
          </a:xfrm>
          <a:prstGeom prst="rect">
            <a:avLst/>
          </a:prstGeom>
        </p:spPr>
      </p:pic>
      <p:pic>
        <p:nvPicPr>
          <p:cNvPr id="20" name="Picture 19" descr="PBMC+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15" r="91873" b="6997"/>
          <a:stretch/>
        </p:blipFill>
        <p:spPr>
          <a:xfrm>
            <a:off x="1269326" y="1045582"/>
            <a:ext cx="387088" cy="855764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3042623" y="902984"/>
            <a:ext cx="488993" cy="135835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2464708" y="896985"/>
            <a:ext cx="621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’ LTR</a:t>
            </a:r>
          </a:p>
        </p:txBody>
      </p:sp>
      <p:cxnSp>
        <p:nvCxnSpPr>
          <p:cNvPr id="23" name="Curved Connector 22"/>
          <p:cNvCxnSpPr>
            <a:cxnSpLocks/>
            <a:stCxn id="21" idx="3"/>
            <a:endCxn id="52" idx="1"/>
          </p:cNvCxnSpPr>
          <p:nvPr/>
        </p:nvCxnSpPr>
        <p:spPr>
          <a:xfrm>
            <a:off x="3531616" y="970902"/>
            <a:ext cx="242158" cy="380087"/>
          </a:xfrm>
          <a:prstGeom prst="curvedConnector3">
            <a:avLst>
              <a:gd name="adj1" fmla="val 50000"/>
            </a:avLst>
          </a:prstGeom>
          <a:ln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Rectangle 27"/>
          <p:cNvSpPr/>
          <p:nvPr/>
        </p:nvSpPr>
        <p:spPr>
          <a:xfrm>
            <a:off x="4625059" y="902984"/>
            <a:ext cx="488993" cy="135835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9" name="Curved Connector 28"/>
          <p:cNvCxnSpPr>
            <a:cxnSpLocks/>
            <a:stCxn id="28" idx="1"/>
            <a:endCxn id="52" idx="3"/>
          </p:cNvCxnSpPr>
          <p:nvPr/>
        </p:nvCxnSpPr>
        <p:spPr>
          <a:xfrm rot="10800000" flipV="1">
            <a:off x="4287187" y="970901"/>
            <a:ext cx="337872" cy="380087"/>
          </a:xfrm>
          <a:prstGeom prst="curvedConnector3">
            <a:avLst>
              <a:gd name="adj1" fmla="val 50000"/>
            </a:avLst>
          </a:prstGeom>
          <a:ln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244110" y="670772"/>
            <a:ext cx="38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548039" y="974265"/>
            <a:ext cx="403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C</a:t>
            </a:r>
          </a:p>
        </p:txBody>
      </p:sp>
      <p:sp>
        <p:nvSpPr>
          <p:cNvPr id="32" name="Arc 31"/>
          <p:cNvSpPr/>
          <p:nvPr/>
        </p:nvSpPr>
        <p:spPr>
          <a:xfrm>
            <a:off x="2917371" y="646924"/>
            <a:ext cx="2282890" cy="423140"/>
          </a:xfrm>
          <a:prstGeom prst="arc">
            <a:avLst>
              <a:gd name="adj1" fmla="val 10479244"/>
              <a:gd name="adj2" fmla="val 253986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5076696" y="878823"/>
            <a:ext cx="621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’ LTR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xmlns="" id="{159C8153-EC16-354C-879B-2102120A6825}"/>
              </a:ext>
            </a:extLst>
          </p:cNvPr>
          <p:cNvSpPr/>
          <p:nvPr/>
        </p:nvSpPr>
        <p:spPr>
          <a:xfrm>
            <a:off x="3773774" y="1277911"/>
            <a:ext cx="513413" cy="146155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F04D4A91-6076-8546-B0FE-637B6DA4C112}"/>
              </a:ext>
            </a:extLst>
          </p:cNvPr>
          <p:cNvCxnSpPr>
            <a:cxnSpLocks/>
          </p:cNvCxnSpPr>
          <p:nvPr/>
        </p:nvCxnSpPr>
        <p:spPr>
          <a:xfrm>
            <a:off x="3766279" y="929390"/>
            <a:ext cx="0" cy="5265295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3D357106-E487-7B40-BDCF-40D4D341DF81}"/>
              </a:ext>
            </a:extLst>
          </p:cNvPr>
          <p:cNvCxnSpPr>
            <a:cxnSpLocks/>
          </p:cNvCxnSpPr>
          <p:nvPr/>
        </p:nvCxnSpPr>
        <p:spPr>
          <a:xfrm>
            <a:off x="4285938" y="929390"/>
            <a:ext cx="0" cy="5265295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24391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71881" y="1419014"/>
            <a:ext cx="9144000" cy="4744514"/>
            <a:chOff x="71881" y="1419014"/>
            <a:chExt cx="9144000" cy="4744514"/>
          </a:xfrm>
        </p:grpSpPr>
        <p:sp>
          <p:nvSpPr>
            <p:cNvPr id="48" name="Rectangle 47"/>
            <p:cNvSpPr/>
            <p:nvPr/>
          </p:nvSpPr>
          <p:spPr>
            <a:xfrm>
              <a:off x="5845543" y="5431954"/>
              <a:ext cx="3169474" cy="17010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638820" y="5431954"/>
              <a:ext cx="1202149" cy="170103"/>
            </a:xfrm>
            <a:prstGeom prst="rect">
              <a:avLst/>
            </a:prstGeom>
            <a:solidFill>
              <a:srgbClr val="DE39E7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3717129" y="5431954"/>
              <a:ext cx="921691" cy="170103"/>
            </a:xfrm>
            <a:prstGeom prst="rect">
              <a:avLst/>
            </a:prstGeom>
            <a:solidFill>
              <a:srgbClr val="FF020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1295400" y="5431954"/>
              <a:ext cx="2421729" cy="170103"/>
            </a:xfrm>
            <a:prstGeom prst="rect">
              <a:avLst/>
            </a:prstGeom>
            <a:solidFill>
              <a:srgbClr val="00D10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20372308"/>
                </p:ext>
              </p:extLst>
            </p:nvPr>
          </p:nvGraphicFramePr>
          <p:xfrm>
            <a:off x="71881" y="1419014"/>
            <a:ext cx="9144000" cy="47445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pSp>
        <p:nvGrpSpPr>
          <p:cNvPr id="42" name="Group 41"/>
          <p:cNvGrpSpPr/>
          <p:nvPr/>
        </p:nvGrpSpPr>
        <p:grpSpPr>
          <a:xfrm>
            <a:off x="1182343" y="438916"/>
            <a:ext cx="7575752" cy="962023"/>
            <a:chOff x="1182343" y="5386763"/>
            <a:chExt cx="7575752" cy="962023"/>
          </a:xfrm>
        </p:grpSpPr>
        <p:grpSp>
          <p:nvGrpSpPr>
            <p:cNvPr id="40" name="Group 39"/>
            <p:cNvGrpSpPr/>
            <p:nvPr/>
          </p:nvGrpSpPr>
          <p:grpSpPr>
            <a:xfrm>
              <a:off x="1182343" y="5386763"/>
              <a:ext cx="7575752" cy="645595"/>
              <a:chOff x="1182343" y="5386763"/>
              <a:chExt cx="7575752" cy="645595"/>
            </a:xfrm>
          </p:grpSpPr>
          <p:grpSp>
            <p:nvGrpSpPr>
              <p:cNvPr id="38" name="Group 37"/>
              <p:cNvGrpSpPr/>
              <p:nvPr/>
            </p:nvGrpSpPr>
            <p:grpSpPr>
              <a:xfrm>
                <a:off x="1182343" y="5759040"/>
                <a:ext cx="7575752" cy="273318"/>
                <a:chOff x="1182343" y="5759040"/>
                <a:chExt cx="7575752" cy="273318"/>
              </a:xfrm>
            </p:grpSpPr>
            <p:cxnSp>
              <p:nvCxnSpPr>
                <p:cNvPr id="16" name="Straight Connector 15"/>
                <p:cNvCxnSpPr/>
                <p:nvPr/>
              </p:nvCxnSpPr>
              <p:spPr>
                <a:xfrm>
                  <a:off x="1182343" y="5759040"/>
                  <a:ext cx="2364686" cy="0"/>
                </a:xfrm>
                <a:prstGeom prst="line">
                  <a:avLst/>
                </a:prstGeom>
                <a:ln>
                  <a:solidFill>
                    <a:srgbClr val="008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4468720" y="5759040"/>
                  <a:ext cx="1202149" cy="0"/>
                </a:xfrm>
                <a:prstGeom prst="line">
                  <a:avLst/>
                </a:prstGeom>
                <a:ln>
                  <a:solidFill>
                    <a:srgbClr val="660066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3547029" y="5759040"/>
                  <a:ext cx="910743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5675443" y="5759040"/>
                  <a:ext cx="308265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Arrow Connector 29"/>
                <p:cNvCxnSpPr/>
                <p:nvPr/>
              </p:nvCxnSpPr>
              <p:spPr>
                <a:xfrm flipV="1">
                  <a:off x="4457772" y="5759040"/>
                  <a:ext cx="0" cy="273318"/>
                </a:xfrm>
                <a:prstGeom prst="straightConnector1">
                  <a:avLst/>
                </a:prstGeom>
                <a:ln>
                  <a:solidFill>
                    <a:srgbClr val="3366FF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Arrow Connector 30"/>
                <p:cNvCxnSpPr/>
                <p:nvPr/>
              </p:nvCxnSpPr>
              <p:spPr>
                <a:xfrm flipV="1">
                  <a:off x="4643881" y="5759040"/>
                  <a:ext cx="0" cy="273318"/>
                </a:xfrm>
                <a:prstGeom prst="straightConnector1">
                  <a:avLst/>
                </a:prstGeom>
                <a:ln>
                  <a:solidFill>
                    <a:srgbClr val="3366FF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Arrow Connector 31"/>
                <p:cNvCxnSpPr/>
                <p:nvPr/>
              </p:nvCxnSpPr>
              <p:spPr>
                <a:xfrm flipV="1">
                  <a:off x="4840939" y="5759040"/>
                  <a:ext cx="0" cy="273318"/>
                </a:xfrm>
                <a:prstGeom prst="straightConnector1">
                  <a:avLst/>
                </a:prstGeom>
                <a:ln>
                  <a:solidFill>
                    <a:srgbClr val="3366FF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TextBox 33"/>
              <p:cNvSpPr txBox="1"/>
              <p:nvPr/>
            </p:nvSpPr>
            <p:spPr>
              <a:xfrm>
                <a:off x="2080048" y="5386763"/>
                <a:ext cx="51953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srgbClr val="3366FF"/>
                    </a:solidFill>
                  </a:rPr>
                  <a:t>LTR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3681470" y="5386763"/>
                <a:ext cx="7104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>
                    <a:solidFill>
                      <a:srgbClr val="FF0000"/>
                    </a:solidFill>
                  </a:rPr>
                  <a:t>Motif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347526" y="5386763"/>
                <a:ext cx="15440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>
                    <a:solidFill>
                      <a:srgbClr val="660066"/>
                    </a:solidFill>
                  </a:rPr>
                  <a:t>Alu Consensus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6788897" y="5386763"/>
                <a:ext cx="9089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non Alu</a:t>
                </a:r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3693500" y="5979454"/>
              <a:ext cx="21980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3366FF"/>
                  </a:solidFill>
                </a:rPr>
                <a:t>Non-consensus Bases</a:t>
              </a: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8072298" y="6488668"/>
            <a:ext cx="1042443" cy="369320"/>
          </a:xfrm>
          <a:prstGeom prst="rect">
            <a:avLst/>
          </a:prstGeom>
          <a:noFill/>
        </p:spPr>
        <p:txBody>
          <a:bodyPr wrap="none" lIns="91429" tIns="45714" rIns="91429" bIns="45714" rtlCol="0">
            <a:spAutoFit/>
          </a:bodyPr>
          <a:lstStyle/>
          <a:p>
            <a:r>
              <a:rPr lang="en-US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1075486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47</TotalTime>
  <Words>96</Words>
  <Application>Microsoft Office PowerPoint</Application>
  <PresentationFormat>On-screen Show (4:3)</PresentationFormat>
  <Paragraphs>38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C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offin</dc:creator>
  <cp:lastModifiedBy>Verbeek, Alex, BioMed Central Ltd.</cp:lastModifiedBy>
  <cp:revision>74</cp:revision>
  <cp:lastPrinted>2019-07-11T19:51:01Z</cp:lastPrinted>
  <dcterms:created xsi:type="dcterms:W3CDTF">2015-06-18T23:54:34Z</dcterms:created>
  <dcterms:modified xsi:type="dcterms:W3CDTF">2020-07-17T13:44:34Z</dcterms:modified>
</cp:coreProperties>
</file>